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2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290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32799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4940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208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7163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1965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1754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5379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843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9623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3952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4600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D52D5-6FFA-4D8B-B3AE-99A61AF316AC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3671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464928"/>
              </p:ext>
            </p:extLst>
          </p:nvPr>
        </p:nvGraphicFramePr>
        <p:xfrm>
          <a:off x="542582" y="1588250"/>
          <a:ext cx="5772837" cy="5802308"/>
        </p:xfrm>
        <a:graphic>
          <a:graphicData uri="http://schemas.openxmlformats.org/drawingml/2006/table">
            <a:tbl>
              <a:tblPr/>
              <a:tblGrid>
                <a:gridCol w="68588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8588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8314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7169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7169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7454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72541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able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3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: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aseline characteristics of the 54 patients with CD enrolled in the study.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2541"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23720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verall population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D patients AIEC-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D patients AIEC+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2541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=54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=41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=13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e at inclusion (years), mean ± SD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0.0 ± 12.0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4.8 ± 9.8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8.5 ± 12.4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emale gender,n (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0 (55.6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5 (61.0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 (38.5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tive smokers,n (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 (35.2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 (34.1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 (38.5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ontreal Classification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     CD location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             L1, n(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 (22.2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 (26.8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 (7.7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             L2, n(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 (11.1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 (14.6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 (0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             L3, n(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6 (66.7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4 (58.5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 (92.3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     CD behaviour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             B1, n(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5 (46.3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1 (51.2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 (30.8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             B2, n(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 (33.3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 (26.8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 (53.8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             B3, n(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 (22.2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 (17.1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 (38.5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urrent medications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             5-ASA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 (3.7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 (4.9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 (0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             Corticosteroids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 (9.3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 (9.8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 (7.7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             Thiopurines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 (31.5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 (31.5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 (31.5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             Methotrexate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 (6.4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 (4.9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 (7.7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             Infliximab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 (14.8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 (17.1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 (7.7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             Adalimumab 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 (22.2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 (21.9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 (23.1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             Vedolizumab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 (1.9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 (0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 (7.7%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DAI, median [25th and 75h percentile]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7.5 [38.2; 223.5]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8.0 [46.0; 214.5]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1.0 [14.5; 246.0]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323720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RP, median [25th and 75h percentile] (mg/L)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4 [0.8; 11.2]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7 [1.1; 11.4]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 [0.6; 9.7]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72541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DEIS,   median [25th and 75h percentile] 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8 [0;3.4]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8 [0;3.6]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3 [0;3.1]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323720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lprotectin,  median [25th and 75h percentile] 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6.6 [52.5; 448.6]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6.6 [46.5; 454.9]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4.0 [100.0; 343.8]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72541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D: standard deviation; n: number; CD: Crohn's disease;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72541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DAI: Crohn Disease Activity Index; CRP: C-reactive protein;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72541">
                <a:tc gridSpan="5"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DEIS: Crohn’s Disease Endoscopic Index score; 5-ASA: acide 5-aminosalicylique.</a:t>
                      </a: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216" marR="8216" marT="821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341022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527</TotalTime>
  <Words>448</Words>
  <Application>Microsoft Office PowerPoint</Application>
  <PresentationFormat>Affichage à l'écran (4:3)</PresentationFormat>
  <Paragraphs>11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lison AGUS</dc:creator>
  <cp:lastModifiedBy>Allison Agus</cp:lastModifiedBy>
  <cp:revision>239</cp:revision>
  <dcterms:created xsi:type="dcterms:W3CDTF">2016-11-08T08:44:13Z</dcterms:created>
  <dcterms:modified xsi:type="dcterms:W3CDTF">2020-08-31T13:56:46Z</dcterms:modified>
</cp:coreProperties>
</file>